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5" autoAdjust="0"/>
    <p:restoredTop sz="94660"/>
  </p:normalViewPr>
  <p:slideViewPr>
    <p:cSldViewPr snapToGrid="0">
      <p:cViewPr>
        <p:scale>
          <a:sx n="70" d="100"/>
          <a:sy n="70" d="100"/>
        </p:scale>
        <p:origin x="-672" y="10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B0D64-B5BD-4E2E-AD91-34F00035ED53}" type="datetimeFigureOut">
              <a:rPr lang="en-GB" smtClean="0"/>
              <a:t>2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59D10-5688-45D7-9177-16492531AC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590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B0D64-B5BD-4E2E-AD91-34F00035ED53}" type="datetimeFigureOut">
              <a:rPr lang="en-GB" smtClean="0"/>
              <a:t>2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59D10-5688-45D7-9177-16492531AC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7035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B0D64-B5BD-4E2E-AD91-34F00035ED53}" type="datetimeFigureOut">
              <a:rPr lang="en-GB" smtClean="0"/>
              <a:t>2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59D10-5688-45D7-9177-16492531AC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0176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B0D64-B5BD-4E2E-AD91-34F00035ED53}" type="datetimeFigureOut">
              <a:rPr lang="en-GB" smtClean="0"/>
              <a:t>2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59D10-5688-45D7-9177-16492531AC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8042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B0D64-B5BD-4E2E-AD91-34F00035ED53}" type="datetimeFigureOut">
              <a:rPr lang="en-GB" smtClean="0"/>
              <a:t>2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59D10-5688-45D7-9177-16492531AC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0909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B0D64-B5BD-4E2E-AD91-34F00035ED53}" type="datetimeFigureOut">
              <a:rPr lang="en-GB" smtClean="0"/>
              <a:t>26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59D10-5688-45D7-9177-16492531AC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9755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B0D64-B5BD-4E2E-AD91-34F00035ED53}" type="datetimeFigureOut">
              <a:rPr lang="en-GB" smtClean="0"/>
              <a:t>26/07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59D10-5688-45D7-9177-16492531AC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3625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B0D64-B5BD-4E2E-AD91-34F00035ED53}" type="datetimeFigureOut">
              <a:rPr lang="en-GB" smtClean="0"/>
              <a:t>26/07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59D10-5688-45D7-9177-16492531AC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9568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B0D64-B5BD-4E2E-AD91-34F00035ED53}" type="datetimeFigureOut">
              <a:rPr lang="en-GB" smtClean="0"/>
              <a:t>26/07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59D10-5688-45D7-9177-16492531AC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4038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B0D64-B5BD-4E2E-AD91-34F00035ED53}" type="datetimeFigureOut">
              <a:rPr lang="en-GB" smtClean="0"/>
              <a:t>26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59D10-5688-45D7-9177-16492531AC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8948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B0D64-B5BD-4E2E-AD91-34F00035ED53}" type="datetimeFigureOut">
              <a:rPr lang="en-GB" smtClean="0"/>
              <a:t>26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59D10-5688-45D7-9177-16492531AC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5942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2B0D64-B5BD-4E2E-AD91-34F00035ED53}" type="datetimeFigureOut">
              <a:rPr lang="en-GB" smtClean="0"/>
              <a:t>26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459D10-5688-45D7-9177-16492531AC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66120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3814" y="323850"/>
            <a:ext cx="5743353" cy="574335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990850" y="323850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798388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204" y="297712"/>
            <a:ext cx="6094228" cy="609422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6411433" y="1299690"/>
            <a:ext cx="5247168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upplementary Figure 1.  Transcriptomic profiles demonstrate a marked difference in WD-PNECs derived from different donors. </a:t>
            </a:r>
          </a:p>
          <a:p>
            <a:r>
              <a:rPr lang="en-GB" dirty="0" smtClean="0"/>
              <a:t>WD-PNECs </a:t>
            </a:r>
            <a:r>
              <a:rPr lang="en-GB" dirty="0"/>
              <a:t>from 4 adult donors were infected with a clinical isolate of SARS-CoV-2 (MOI=0.1) or mock infected. At 48 and 96 </a:t>
            </a:r>
            <a:r>
              <a:rPr lang="en-GB" dirty="0" err="1"/>
              <a:t>hpi</a:t>
            </a:r>
            <a:r>
              <a:rPr lang="en-GB" dirty="0"/>
              <a:t> RNA was extracted from the cultures and global transcriptomic analysis was performed. </a:t>
            </a:r>
            <a:r>
              <a:rPr lang="en-GB" dirty="0" smtClean="0"/>
              <a:t>Selected </a:t>
            </a:r>
            <a:r>
              <a:rPr lang="en-GB" dirty="0"/>
              <a:t>genes, pertaining to </a:t>
            </a:r>
            <a:r>
              <a:rPr lang="en-GB" dirty="0" smtClean="0"/>
              <a:t>the IFIH1-mediated induction of interferon (A) and Toll-like receptor signalling (B) are illustrated </a:t>
            </a:r>
            <a:r>
              <a:rPr lang="en-GB" dirty="0"/>
              <a:t>by </a:t>
            </a:r>
            <a:r>
              <a:rPr lang="en-GB" dirty="0" err="1"/>
              <a:t>heatmap</a:t>
            </a:r>
            <a:r>
              <a:rPr lang="en-GB" dirty="0"/>
              <a:t>, gene upregulation (Red) and down regulation (blue</a:t>
            </a:r>
            <a:r>
              <a:rPr lang="en-GB" dirty="0" smtClean="0"/>
              <a:t>). </a:t>
            </a:r>
            <a:endParaRPr lang="en-GB" dirty="0"/>
          </a:p>
        </p:txBody>
      </p:sp>
      <p:sp>
        <p:nvSpPr>
          <p:cNvPr id="4" name="TextBox 3"/>
          <p:cNvSpPr txBox="1"/>
          <p:nvPr/>
        </p:nvSpPr>
        <p:spPr>
          <a:xfrm>
            <a:off x="317204" y="297712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205050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47</TotalTime>
  <Words>93</Words>
  <Application>Microsoft Office PowerPoint</Application>
  <PresentationFormat>Widescreen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dsay Broadbent</dc:creator>
  <cp:lastModifiedBy>Lindsay Broadbent</cp:lastModifiedBy>
  <cp:revision>9</cp:revision>
  <dcterms:created xsi:type="dcterms:W3CDTF">2021-07-26T13:17:16Z</dcterms:created>
  <dcterms:modified xsi:type="dcterms:W3CDTF">2021-07-28T11:04:51Z</dcterms:modified>
</cp:coreProperties>
</file>